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6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081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331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500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926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936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730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304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28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717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081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135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536E6F-DC91-4B93-AB5D-58FC3ACA355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92BBA-0F74-4723-B0FF-F02AB5208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533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154116" y="663086"/>
            <a:ext cx="8379070" cy="5307029"/>
            <a:chOff x="2154116" y="663086"/>
            <a:chExt cx="8379070" cy="530702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09925" y="663086"/>
              <a:ext cx="5772150" cy="401955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154116" y="5046785"/>
              <a:ext cx="837907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:  </a:t>
              </a:r>
              <a:r>
                <a:rPr lang="en-US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-</a:t>
              </a:r>
              <a:r>
                <a:rPr lang="en-US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ilico</a:t>
              </a:r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odology for the identification miRNAs and target prediction in 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arl millet.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920642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PBRF (ICRISAT-IN)</dc:creator>
  <cp:lastModifiedBy>CPBRF (ICRISAT-IN)</cp:lastModifiedBy>
  <cp:revision>3</cp:revision>
  <dcterms:created xsi:type="dcterms:W3CDTF">2020-07-01T05:32:41Z</dcterms:created>
  <dcterms:modified xsi:type="dcterms:W3CDTF">2020-07-01T05:51:38Z</dcterms:modified>
</cp:coreProperties>
</file>